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9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120" y="7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19\&#49892;&#54744;\0.&#54861;&#49340;&#45796;&#45817;&#52404;\&#47732;&#50669;\%5braw%20data%5d&#47560;&#50864;&#49828;_20190529_&#54861;&#49340;_&#54861;&#49340;&#45796;&#45817;&#52404;_&#47732;&#50669;&#48708;&#44368;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E:\2019\&#49892;&#54744;\0.&#54861;&#49340;&#45796;&#45817;&#52404;\&#47732;&#50669;\%5braw%20data%5d&#47560;&#50864;&#49828;_20190529_&#54861;&#49340;_&#54861;&#49340;&#45796;&#45817;&#52404;_&#47732;&#50669;&#48708;&#44368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46866980099465"/>
          <c:y val="5.0989255118581801E-2"/>
          <c:w val="0.75583931041408747"/>
          <c:h val="0.752843972544761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Lbl>
              <c:idx val="0"/>
              <c:delete val="1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3ABC-4D38-A298-0446590C6FE3}"/>
                </c:ext>
                <c:ext xmlns:c15="http://schemas.microsoft.com/office/drawing/2012/chart" uri="{CE6537A1-D6FC-4f65-9D91-7224C49458BB}"/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ko-KR"/>
                      <a:t>*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3ABC-4D38-A298-0446590C6FE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delete val="1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2-3ABC-4D38-A298-0446590C6FE3}"/>
                </c:ext>
                <c:ext xmlns:c15="http://schemas.microsoft.com/office/drawing/2012/chart" uri="{CE6537A1-D6FC-4f65-9D91-7224C49458BB}"/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altLang="ko-KR"/>
                      <a:t>##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3-3ABC-4D38-A298-0446590C6FE3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delete val="1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4-3ABC-4D38-A298-0446590C6FE3}"/>
                </c:ex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400"/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</c:ext>
            </c:extLst>
          </c:dLbls>
          <c:errBars>
            <c:errBarType val="plus"/>
            <c:errValType val="cust"/>
            <c:noEndCap val="0"/>
            <c:plus>
              <c:numRef>
                <c:f>수현그래프2!$C$111:$C$115</c:f>
                <c:numCache>
                  <c:formatCode>General</c:formatCode>
                  <c:ptCount val="5"/>
                  <c:pt idx="0">
                    <c:v>64.294663160619322</c:v>
                  </c:pt>
                  <c:pt idx="1">
                    <c:v>0.36309218870694532</c:v>
                  </c:pt>
                  <c:pt idx="2">
                    <c:v>3.3145630368119412</c:v>
                  </c:pt>
                  <c:pt idx="3">
                    <c:v>1.4371602859458648</c:v>
                  </c:pt>
                  <c:pt idx="4">
                    <c:v>1.10926495933117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수현그래프2!$B$104:$B$108</c:f>
              <c:strCache>
                <c:ptCount val="5"/>
                <c:pt idx="0">
                  <c:v>Normal </c:v>
                </c:pt>
                <c:pt idx="1">
                  <c:v>CY control</c:v>
                </c:pt>
                <c:pt idx="2">
                  <c:v>NSF 75</c:v>
                </c:pt>
                <c:pt idx="3">
                  <c:v>NSF 150</c:v>
                </c:pt>
                <c:pt idx="4">
                  <c:v>NSF 300</c:v>
                </c:pt>
              </c:strCache>
            </c:strRef>
          </c:cat>
          <c:val>
            <c:numRef>
              <c:f>수현그래프2!$C$104:$C$108</c:f>
              <c:numCache>
                <c:formatCode>0.00_);[Red]\(0.00\)</c:formatCode>
                <c:ptCount val="5"/>
                <c:pt idx="0">
                  <c:v>576</c:v>
                </c:pt>
                <c:pt idx="1">
                  <c:v>4.5</c:v>
                </c:pt>
                <c:pt idx="2">
                  <c:v>13.125</c:v>
                </c:pt>
                <c:pt idx="3">
                  <c:v>11.625</c:v>
                </c:pt>
                <c:pt idx="4">
                  <c:v>6.3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3ABC-4D38-A298-0446590C6F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17013872"/>
        <c:axId val="2017023664"/>
      </c:barChart>
      <c:catAx>
        <c:axId val="2017013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0"/>
            </a:pPr>
            <a:endParaRPr lang="ko-KR"/>
          </a:p>
        </c:txPr>
        <c:crossAx val="2017023664"/>
        <c:crosses val="autoZero"/>
        <c:auto val="1"/>
        <c:lblAlgn val="ctr"/>
        <c:lblOffset val="100"/>
        <c:noMultiLvlLbl val="0"/>
      </c:catAx>
      <c:valAx>
        <c:axId val="2017023664"/>
        <c:scaling>
          <c:logBase val="10"/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 b="0">
                    <a:latin typeface="+mn-lt"/>
                  </a:defRPr>
                </a:pPr>
                <a:r>
                  <a:rPr lang="en-US" sz="1600" b="0">
                    <a:latin typeface="+mn-lt"/>
                  </a:rPr>
                  <a:t>AFCs / spleen</a:t>
                </a:r>
                <a:endParaRPr lang="ko-KR" sz="1600" b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3.4832899135232666E-2"/>
              <c:y val="0.27044915043001272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sz="1400" b="1"/>
            </a:pPr>
            <a:endParaRPr lang="ko-KR"/>
          </a:p>
        </c:txPr>
        <c:crossAx val="201701387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KT&amp;G 상상본문 L" panose="02000300000000000000" pitchFamily="2" charset="-127"/>
          <a:ea typeface="KT&amp;G 상상본문 L" panose="02000300000000000000" pitchFamily="2" charset="-127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Lbls>
            <c:dLbl>
              <c:idx val="0"/>
              <c:delete val="1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DA5B-459F-B708-DD5E56A9501A}"/>
                </c:ext>
                <c:ext xmlns:c15="http://schemas.microsoft.com/office/drawing/2012/chart" uri="{CE6537A1-D6FC-4f65-9D91-7224C49458BB}"/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ko-KR"/>
                      <a:t>*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DA5B-459F-B708-DD5E56A9501A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altLang="ko-KR"/>
                      <a:t>#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2-DA5B-459F-B708-DD5E56A9501A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altLang="ko-KR"/>
                      <a:t>#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3-DA5B-459F-B708-DD5E56A9501A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delete val="1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4-DA5B-459F-B708-DD5E56A9501A}"/>
                </c:ex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400"/>
                </a:pPr>
                <a:endParaRPr lang="ko-KR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</c:ext>
            </c:extLst>
          </c:dLbls>
          <c:errBars>
            <c:errBarType val="plus"/>
            <c:errValType val="cust"/>
            <c:noEndCap val="0"/>
            <c:plus>
              <c:numRef>
                <c:f>수현그래프2!$D$111:$D$115</c:f>
                <c:numCache>
                  <c:formatCode>General</c:formatCode>
                  <c:ptCount val="5"/>
                  <c:pt idx="0">
                    <c:v>82.741563460908495</c:v>
                  </c:pt>
                  <c:pt idx="1">
                    <c:v>1.1573671392646354</c:v>
                  </c:pt>
                  <c:pt idx="2">
                    <c:v>7.2505348666786134</c:v>
                  </c:pt>
                  <c:pt idx="3">
                    <c:v>3.4379313347304117</c:v>
                  </c:pt>
                  <c:pt idx="4">
                    <c:v>2.82330694969224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수현그래프2!$B$104:$B$108</c:f>
              <c:strCache>
                <c:ptCount val="5"/>
                <c:pt idx="0">
                  <c:v>Normal </c:v>
                </c:pt>
                <c:pt idx="1">
                  <c:v>CY control</c:v>
                </c:pt>
                <c:pt idx="2">
                  <c:v>NSF 75</c:v>
                </c:pt>
                <c:pt idx="3">
                  <c:v>NSF 150</c:v>
                </c:pt>
                <c:pt idx="4">
                  <c:v>NSF 300</c:v>
                </c:pt>
              </c:strCache>
            </c:strRef>
          </c:cat>
          <c:val>
            <c:numRef>
              <c:f>수현그래프2!$D$104:$D$108</c:f>
              <c:numCache>
                <c:formatCode>0.00_);[Red]\(0.00\)</c:formatCode>
                <c:ptCount val="5"/>
                <c:pt idx="0">
                  <c:v>772.77924296938386</c:v>
                </c:pt>
                <c:pt idx="1">
                  <c:v>16.270931464107168</c:v>
                </c:pt>
                <c:pt idx="2">
                  <c:v>37.953065855400638</c:v>
                </c:pt>
                <c:pt idx="3">
                  <c:v>27.910987079305407</c:v>
                </c:pt>
                <c:pt idx="4">
                  <c:v>20.1248756353371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DA5B-459F-B708-DD5E56A950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2"/>
        <c:axId val="2017019312"/>
        <c:axId val="2017014416"/>
      </c:barChart>
      <c:catAx>
        <c:axId val="20170193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 b="0">
                <a:latin typeface="+mn-lt"/>
              </a:defRPr>
            </a:pPr>
            <a:endParaRPr lang="ko-KR"/>
          </a:p>
        </c:txPr>
        <c:crossAx val="2017014416"/>
        <c:crosses val="autoZero"/>
        <c:auto val="1"/>
        <c:lblAlgn val="ctr"/>
        <c:lblOffset val="100"/>
        <c:noMultiLvlLbl val="0"/>
      </c:catAx>
      <c:valAx>
        <c:axId val="2017014416"/>
        <c:scaling>
          <c:logBase val="10"/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 b="0">
                    <a:latin typeface="+mn-lt"/>
                  </a:defRPr>
                </a:pPr>
                <a:r>
                  <a:rPr lang="en-US" sz="1600" b="0" dirty="0">
                    <a:latin typeface="+mn-lt"/>
                  </a:rPr>
                  <a:t>AFCs X 10</a:t>
                </a:r>
                <a:r>
                  <a:rPr lang="en-US" sz="1600" b="0" baseline="30000" dirty="0">
                    <a:latin typeface="+mn-lt"/>
                  </a:rPr>
                  <a:t>6</a:t>
                </a:r>
                <a:r>
                  <a:rPr lang="en-US" sz="1600" b="0" dirty="0">
                    <a:latin typeface="+mn-lt"/>
                  </a:rPr>
                  <a:t> cells</a:t>
                </a:r>
                <a:endParaRPr lang="ko-KR" sz="1600" b="0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4.7958824961794343E-2"/>
              <c:y val="0.22226832508199446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sz="1400" b="1">
                <a:latin typeface="+mn-lt"/>
              </a:defRPr>
            </a:pPr>
            <a:endParaRPr lang="ko-KR"/>
          </a:p>
        </c:txPr>
        <c:crossAx val="20170193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KT&amp;G 상상본문 L" panose="02000300000000000000" pitchFamily="2" charset="-127"/>
          <a:ea typeface="KT&amp;G 상상본문 L" panose="02000300000000000000" pitchFamily="2" charset="-127"/>
        </a:defRPr>
      </a:pPr>
      <a:endParaRPr lang="ko-KR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5161</cdr:x>
      <cdr:y>0.79618</cdr:y>
    </cdr:from>
    <cdr:to>
      <cdr:x>0.93743</cdr:x>
      <cdr:y>0.97338</cdr:y>
    </cdr:to>
    <cdr:sp macro="" textlink="">
      <cdr:nvSpPr>
        <cdr:cNvPr id="2" name="직사각형 1"/>
        <cdr:cNvSpPr/>
      </cdr:nvSpPr>
      <cdr:spPr>
        <a:xfrm xmlns:a="http://schemas.openxmlformats.org/drawingml/2006/main">
          <a:off x="2552990" y="2390883"/>
          <a:ext cx="1785659" cy="532126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ko-KR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61702F-3159-4176-A549-F57C46F01B3E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0D7359-307D-4F9B-81C4-9B6458800E2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7335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8975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9239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0256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335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8476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1084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942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5294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790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4212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78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AFCA2-ECA3-4CDC-A221-3CA99B4EB4E2}" type="datetimeFigureOut">
              <a:rPr lang="ko-KR" altLang="en-US" smtClean="0"/>
              <a:t>2020-06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F33C0-DC12-417F-BF91-6A110A0811D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121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406431" y="136058"/>
            <a:ext cx="41229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 smtClean="0">
                <a:ea typeface="KT&amp;G 상상본문 L" panose="020B0600000101010101" pitchFamily="50" charset="-127"/>
                <a:cs typeface="Times New Roman" pitchFamily="18" charset="0"/>
              </a:rPr>
              <a:t>a.</a:t>
            </a:r>
            <a:endParaRPr lang="ko-KR" altLang="en-US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2631582"/>
              </p:ext>
            </p:extLst>
          </p:nvPr>
        </p:nvGraphicFramePr>
        <p:xfrm>
          <a:off x="2721702" y="3873648"/>
          <a:ext cx="8651438" cy="2782161"/>
        </p:xfrm>
        <a:graphic>
          <a:graphicData uri="http://schemas.openxmlformats.org/drawingml/2006/table">
            <a:tbl>
              <a:tblPr/>
              <a:tblGrid>
                <a:gridCol w="1498606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434904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444086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424614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424614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424614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</a:tblGrid>
              <a:tr h="723362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Group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Body </a:t>
                      </a:r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weight</a:t>
                      </a:r>
                    </a:p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(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Absolute organ weights (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Relative organ weights (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50078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Splee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Thym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Splee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Thymu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116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Norma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KT&amp;G 상상본문 L" panose="02000300000000000000" pitchFamily="2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23.05±1.3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12±0.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06±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50±0.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25±0.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116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CY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contro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21.83±2.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 0.07±0.01**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KT&amp;G 상상본문 L" panose="02000300000000000000" pitchFamily="2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  0.04±0.01**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KT&amp;G 상상본문 L" panose="02000300000000000000" pitchFamily="2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   0.32±0.02**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KT&amp;G 상상본문 L" panose="02000300000000000000" pitchFamily="2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   0.17±0.03**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KT&amp;G 상상본문 L" panose="02000300000000000000" pitchFamily="2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116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NFP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75 mg/k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23.66±0.8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08±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04±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32±0.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19±0.05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KT&amp;G 상상본문 L" panose="02000300000000000000" pitchFamily="2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3116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NFP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150 mg/k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23.68±0.7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08±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   0.05±0.00</a:t>
                      </a:r>
                      <a:r>
                        <a:rPr lang="en-US" altLang="ko-KR" sz="14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##</a:t>
                      </a:r>
                      <a:endParaRPr lang="en-US" altLang="ko-KR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KT&amp;G 상상본문 L" panose="02000300000000000000" pitchFamily="2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33±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82296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0.21±0.01</a:t>
                      </a:r>
                      <a:r>
                        <a:rPr lang="en-US" altLang="ko-KR" sz="1400" b="0" i="0" u="none" strike="noStrike" baseline="30000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#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KT&amp;G 상상본문 L" panose="02000300000000000000" pitchFamily="2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1160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  NFP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300 mg/k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23.07±0.7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07±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05±0.0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29±0.0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KT&amp;G 상상본문 L" panose="02000300000000000000" pitchFamily="2" charset="-127"/>
                        </a:rPr>
                        <a:t>0.20±0.0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KT&amp;G 상상본문 L" panose="02000300000000000000" pitchFamily="2" charset="-127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5309986"/>
              </p:ext>
            </p:extLst>
          </p:nvPr>
        </p:nvGraphicFramePr>
        <p:xfrm>
          <a:off x="2352661" y="514044"/>
          <a:ext cx="4739772" cy="29888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" name="그룹 4"/>
          <p:cNvGrpSpPr/>
          <p:nvPr/>
        </p:nvGrpSpPr>
        <p:grpSpPr>
          <a:xfrm>
            <a:off x="6700217" y="184855"/>
            <a:ext cx="4672924" cy="3375253"/>
            <a:chOff x="14792119" y="27408274"/>
            <a:chExt cx="5998828" cy="3375253"/>
          </a:xfrm>
        </p:grpSpPr>
        <p:sp>
          <p:nvSpPr>
            <p:cNvPr id="6" name="직사각형 5"/>
            <p:cNvSpPr/>
            <p:nvPr/>
          </p:nvSpPr>
          <p:spPr>
            <a:xfrm>
              <a:off x="14792119" y="27408274"/>
              <a:ext cx="56014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2400" dirty="0" smtClean="0">
                  <a:ea typeface="KT&amp;G 상상본문 L" panose="020B0600000101010101" pitchFamily="50" charset="-127"/>
                  <a:cs typeface="Times New Roman" pitchFamily="18" charset="0"/>
                </a:rPr>
                <a:t>b.</a:t>
              </a:r>
              <a:endParaRPr lang="ko-KR" altLang="en-US" dirty="0"/>
            </a:p>
          </p:txBody>
        </p:sp>
        <p:graphicFrame>
          <p:nvGraphicFramePr>
            <p:cNvPr id="7" name="차트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89132161"/>
                </p:ext>
              </p:extLst>
            </p:nvPr>
          </p:nvGraphicFramePr>
          <p:xfrm>
            <a:off x="14849481" y="27780580"/>
            <a:ext cx="5941466" cy="30029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8" name="직사각형 7"/>
          <p:cNvSpPr/>
          <p:nvPr/>
        </p:nvSpPr>
        <p:spPr>
          <a:xfrm>
            <a:off x="2427982" y="3395935"/>
            <a:ext cx="39786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2400" dirty="0" smtClean="0">
                <a:ea typeface="KT&amp;G 상상본문 L" panose="020B0600000101010101" pitchFamily="50" charset="-127"/>
                <a:cs typeface="Times New Roman" pitchFamily="18" charset="0"/>
              </a:rPr>
              <a:t>c.</a:t>
            </a:r>
            <a:endParaRPr lang="ko-KR" altLang="en-US" dirty="0"/>
          </a:p>
        </p:txBody>
      </p:sp>
      <p:sp>
        <p:nvSpPr>
          <p:cNvPr id="9" name="TextBox 1"/>
          <p:cNvSpPr txBox="1"/>
          <p:nvPr/>
        </p:nvSpPr>
        <p:spPr>
          <a:xfrm>
            <a:off x="10599244" y="3162319"/>
            <a:ext cx="714845" cy="240319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100" dirty="0" smtClean="0">
                <a:ea typeface="KT&amp;G 상상본문 L" panose="02000300000000000000" pitchFamily="2" charset="-127"/>
              </a:rPr>
              <a:t>(mg/kg)</a:t>
            </a:r>
            <a:endParaRPr lang="ko-KR" altLang="en-US" sz="1100" dirty="0">
              <a:ea typeface="KT&amp;G 상상본문 L" panose="02000300000000000000" pitchFamily="2" charset="-127"/>
            </a:endParaRPr>
          </a:p>
        </p:txBody>
      </p:sp>
      <p:sp>
        <p:nvSpPr>
          <p:cNvPr id="10" name="TextBox 1"/>
          <p:cNvSpPr txBox="1"/>
          <p:nvPr/>
        </p:nvSpPr>
        <p:spPr>
          <a:xfrm>
            <a:off x="6343777" y="3212646"/>
            <a:ext cx="714845" cy="240319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100" dirty="0" smtClean="0">
                <a:ea typeface="KT&amp;G 상상본문 L" panose="02000300000000000000" pitchFamily="2" charset="-127"/>
              </a:rPr>
              <a:t>(mg/kg)</a:t>
            </a:r>
            <a:endParaRPr lang="ko-KR" altLang="en-US" sz="1100" dirty="0">
              <a:ea typeface="KT&amp;G 상상본문 L" panose="02000300000000000000" pitchFamily="2" charset="-127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800322" y="3007835"/>
            <a:ext cx="71686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NFP 75</a:t>
            </a:r>
            <a:endParaRPr lang="ko-KR" alt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5509780" y="3007836"/>
            <a:ext cx="72167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NFP150</a:t>
            </a:r>
            <a:endParaRPr lang="ko-KR" alt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6189348" y="3001812"/>
            <a:ext cx="8066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NFP 300</a:t>
            </a:r>
            <a:endParaRPr lang="ko-KR" alt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9326829" y="2947156"/>
            <a:ext cx="71686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NFP 75</a:t>
            </a:r>
            <a:endParaRPr lang="ko-KR" alt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9916011" y="2947155"/>
            <a:ext cx="8066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NFP150 </a:t>
            </a:r>
            <a:endParaRPr lang="ko-KR" alt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10560853" y="2948398"/>
            <a:ext cx="80663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NFP 300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1746437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5581" y="319902"/>
            <a:ext cx="8163511" cy="59643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09369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8</TotalTime>
  <Words>110</Words>
  <Application>Microsoft Office PowerPoint</Application>
  <PresentationFormat>와이드스크린</PresentationFormat>
  <Paragraphs>57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KT&amp;G 상상본문 L</vt:lpstr>
      <vt:lpstr>맑은 고딕</vt:lpstr>
      <vt:lpstr>Arial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n</dc:creator>
  <cp:lastModifiedBy>Windows 사용자</cp:lastModifiedBy>
  <cp:revision>11</cp:revision>
  <dcterms:created xsi:type="dcterms:W3CDTF">2020-05-11T15:16:05Z</dcterms:created>
  <dcterms:modified xsi:type="dcterms:W3CDTF">2020-06-19T01:07:44Z</dcterms:modified>
</cp:coreProperties>
</file>